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116" d="100"/>
          <a:sy n="116" d="100"/>
        </p:scale>
        <p:origin x="336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1063186-45B9-499D-A7E9-CC7B51C75434}" type="datetimeFigureOut">
              <a:rPr lang="en-US" smtClean="0"/>
              <a:t>9/7/20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90E03DB-C844-47A9-BA08-969FC8CEB6A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5858103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Supplementary Table S3B. </a:t>
            </a:r>
            <a:r>
              <a:rPr lang="en-US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oncordance between assays for tumor suppressor aberrancy calls (sufficient samples only)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lang="en-US" sz="2800" b="0" i="0" u="none" strike="noStrike" cap="none" baseline="0" dirty="0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Sufficient: excludes ctDNA samples that had low tumor content resulting in indeterminate findings that cannot rule out false negatives; </a:t>
            </a:r>
            <a:r>
              <a:rPr lang="en-US" sz="2800" b="0" i="0" u="none" strike="noStrike" cap="none" dirty="0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IHC: Immunohistochemistry; stDNA: solid tumor next generation sequencing; ctDNA:</a:t>
            </a:r>
            <a:r>
              <a:rPr lang="en-US" sz="2800" b="0" i="0" u="none" strike="noStrike" cap="none" baseline="0" dirty="0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 circulating tumor next generation sequencing; stDNA adjusted: solid tumor next generation sequencing incorporating analysis of </a:t>
            </a:r>
            <a:r>
              <a:rPr lang="en-US" sz="2800" b="0" i="0" u="none" strike="noStrike" cap="none" dirty="0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deletion CNVs using a threshold of copy number ≤1.5 which was not validated for this assay</a:t>
            </a:r>
            <a:endParaRPr lang="en-US" sz="2800" dirty="0"/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altLang="en-US" sz="2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idx="10"/>
          </p:nvPr>
        </p:nvSpPr>
        <p:spPr/>
        <p:txBody>
          <a:bodyPr/>
          <a:lstStyle/>
          <a:p>
            <a:pPr marL="0" marR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 sz="1200" b="0" i="0" u="none" strike="noStrike" cap="none" smtClean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1</a:t>
            </a:fld>
            <a:endParaRPr lang="en-US" sz="1200" b="0" i="0" u="none" strike="noStrike" cap="none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425505698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E47642-1414-4E83-A4A8-93174E28D978}" type="datetimeFigureOut">
              <a:rPr lang="en-US" smtClean="0"/>
              <a:t>9/7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0C57C8-3E23-498A-A942-868D04CA592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5384197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E47642-1414-4E83-A4A8-93174E28D978}" type="datetimeFigureOut">
              <a:rPr lang="en-US" smtClean="0"/>
              <a:t>9/7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0C57C8-3E23-498A-A942-868D04CA592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9759356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E47642-1414-4E83-A4A8-93174E28D978}" type="datetimeFigureOut">
              <a:rPr lang="en-US" smtClean="0"/>
              <a:t>9/7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0C57C8-3E23-498A-A942-868D04CA592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5460348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E47642-1414-4E83-A4A8-93174E28D978}" type="datetimeFigureOut">
              <a:rPr lang="en-US" smtClean="0"/>
              <a:t>9/7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0C57C8-3E23-498A-A942-868D04CA592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2410847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E47642-1414-4E83-A4A8-93174E28D978}" type="datetimeFigureOut">
              <a:rPr lang="en-US" smtClean="0"/>
              <a:t>9/7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0C57C8-3E23-498A-A942-868D04CA592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6502948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E47642-1414-4E83-A4A8-93174E28D978}" type="datetimeFigureOut">
              <a:rPr lang="en-US" smtClean="0"/>
              <a:t>9/7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0C57C8-3E23-498A-A942-868D04CA592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0328128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E47642-1414-4E83-A4A8-93174E28D978}" type="datetimeFigureOut">
              <a:rPr lang="en-US" smtClean="0"/>
              <a:t>9/7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0C57C8-3E23-498A-A942-868D04CA592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5530751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E47642-1414-4E83-A4A8-93174E28D978}" type="datetimeFigureOut">
              <a:rPr lang="en-US" smtClean="0"/>
              <a:t>9/7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0C57C8-3E23-498A-A942-868D04CA592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2549698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E47642-1414-4E83-A4A8-93174E28D978}" type="datetimeFigureOut">
              <a:rPr lang="en-US" smtClean="0"/>
              <a:t>9/7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0C57C8-3E23-498A-A942-868D04CA592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3915893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E47642-1414-4E83-A4A8-93174E28D978}" type="datetimeFigureOut">
              <a:rPr lang="en-US" smtClean="0"/>
              <a:t>9/7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0C57C8-3E23-498A-A942-868D04CA592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0772418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E47642-1414-4E83-A4A8-93174E28D978}" type="datetimeFigureOut">
              <a:rPr lang="en-US" smtClean="0"/>
              <a:t>9/7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0C57C8-3E23-498A-A942-868D04CA592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7204023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5E47642-1414-4E83-A4A8-93174E28D978}" type="datetimeFigureOut">
              <a:rPr lang="en-US" smtClean="0"/>
              <a:t>9/7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10C57C8-3E23-498A-A942-868D04CA592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0397716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4"/>
          <p:cNvSpPr/>
          <p:nvPr/>
        </p:nvSpPr>
        <p:spPr>
          <a:xfrm>
            <a:off x="2884488" y="122337"/>
            <a:ext cx="6396303" cy="28995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>
              <a:lnSpc>
                <a:spcPct val="107000"/>
              </a:lnSpc>
            </a:pPr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able S3B. Concordance between assays for tumor suppressor aberrancy calls for sufficient samples.</a:t>
            </a:r>
            <a:endParaRPr lang="en-US" sz="105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graphicFrame>
        <p:nvGraphicFramePr>
          <p:cNvPr id="2" name="Table 1"/>
          <p:cNvGraphicFramePr>
            <a:graphicFrameLocks noGrp="1"/>
          </p:cNvGraphicFramePr>
          <p:nvPr>
            <p:extLst/>
          </p:nvPr>
        </p:nvGraphicFramePr>
        <p:xfrm>
          <a:off x="0" y="480109"/>
          <a:ext cx="5809298" cy="3032897"/>
        </p:xfrm>
        <a:graphic>
          <a:graphicData uri="http://schemas.openxmlformats.org/drawingml/2006/table">
            <a:tbl>
              <a:tblPr/>
              <a:tblGrid>
                <a:gridCol w="1314450">
                  <a:extLst>
                    <a:ext uri="{9D8B030D-6E8A-4147-A177-3AD203B41FA5}">
                      <a16:colId xmlns:a16="http://schemas.microsoft.com/office/drawing/2014/main" val="3346959804"/>
                    </a:ext>
                  </a:extLst>
                </a:gridCol>
                <a:gridCol w="1435735">
                  <a:extLst>
                    <a:ext uri="{9D8B030D-6E8A-4147-A177-3AD203B41FA5}">
                      <a16:colId xmlns:a16="http://schemas.microsoft.com/office/drawing/2014/main" val="2057652616"/>
                    </a:ext>
                  </a:extLst>
                </a:gridCol>
                <a:gridCol w="944563">
                  <a:extLst>
                    <a:ext uri="{9D8B030D-6E8A-4147-A177-3AD203B41FA5}">
                      <a16:colId xmlns:a16="http://schemas.microsoft.com/office/drawing/2014/main" val="182810040"/>
                    </a:ext>
                  </a:extLst>
                </a:gridCol>
                <a:gridCol w="611505">
                  <a:extLst>
                    <a:ext uri="{9D8B030D-6E8A-4147-A177-3AD203B41FA5}">
                      <a16:colId xmlns:a16="http://schemas.microsoft.com/office/drawing/2014/main" val="2612264985"/>
                    </a:ext>
                  </a:extLst>
                </a:gridCol>
                <a:gridCol w="131445">
                  <a:extLst>
                    <a:ext uri="{9D8B030D-6E8A-4147-A177-3AD203B41FA5}">
                      <a16:colId xmlns:a16="http://schemas.microsoft.com/office/drawing/2014/main" val="2763505927"/>
                    </a:ext>
                  </a:extLst>
                </a:gridCol>
                <a:gridCol w="432435">
                  <a:extLst>
                    <a:ext uri="{9D8B030D-6E8A-4147-A177-3AD203B41FA5}">
                      <a16:colId xmlns:a16="http://schemas.microsoft.com/office/drawing/2014/main" val="3457180798"/>
                    </a:ext>
                  </a:extLst>
                </a:gridCol>
                <a:gridCol w="939165">
                  <a:extLst>
                    <a:ext uri="{9D8B030D-6E8A-4147-A177-3AD203B41FA5}">
                      <a16:colId xmlns:a16="http://schemas.microsoft.com/office/drawing/2014/main" val="2222483457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P53</a:t>
                      </a:r>
                      <a:r>
                        <a:rPr lang="en-US" sz="900" b="1" baseline="30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ctDNAnor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P53</a:t>
                      </a:r>
                      <a:r>
                        <a:rPr lang="en-US" sz="900" b="1" baseline="30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ctDNAabn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 b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Total</a:t>
                      </a:r>
                      <a:endParaRPr lang="en-US" sz="9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Kappa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(95% CI)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28960656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P53</a:t>
                      </a:r>
                      <a:r>
                        <a:rPr lang="en-US" sz="900" b="1" baseline="30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IHCnor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4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6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-0.11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(-0.61, 0.39)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4043055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P53</a:t>
                      </a:r>
                      <a:r>
                        <a:rPr lang="en-US" sz="900" b="1" baseline="30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IHCabn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4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5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9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13523813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Total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6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9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5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0469050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P53</a:t>
                      </a:r>
                      <a:r>
                        <a:rPr lang="en-US" sz="900" b="1" baseline="30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stDNAnor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P53</a:t>
                      </a:r>
                      <a:r>
                        <a:rPr lang="en-US" sz="900" b="1" baseline="30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stDNAabn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Total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Kappa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(95% CI)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52831468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P53</a:t>
                      </a:r>
                      <a:r>
                        <a:rPr lang="en-US" sz="900" b="1" baseline="30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IHCnor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3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.13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(-0.37, 0.62)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27432665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P53</a:t>
                      </a:r>
                      <a:r>
                        <a:rPr lang="en-US" sz="900" b="1" baseline="30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IHCabn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4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4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8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980247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Total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6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5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1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80080394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P53</a:t>
                      </a:r>
                      <a:r>
                        <a:rPr lang="en-US" sz="900" b="1" baseline="30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ctDNAnor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P53</a:t>
                      </a:r>
                      <a:r>
                        <a:rPr lang="en-US" sz="900" b="1" baseline="30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ctDNAabn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Total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Kappa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(95% CI)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10150815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P53</a:t>
                      </a:r>
                      <a:r>
                        <a:rPr lang="en-US" sz="900" b="1" baseline="30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stDNAnor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3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3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6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.48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(0.05, 0.91)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44109292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P53</a:t>
                      </a:r>
                      <a:r>
                        <a:rPr lang="en-US" sz="900" b="1" baseline="30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stDNAabn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5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5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65608736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Total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3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8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1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90541389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 b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P53</a:t>
                      </a:r>
                      <a:r>
                        <a:rPr lang="en-US" sz="900" b="1" baseline="300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stDNA</a:t>
                      </a:r>
                      <a:r>
                        <a:rPr lang="en-US" sz="900" b="1" baseline="300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adjusted</a:t>
                      </a:r>
                      <a:r>
                        <a:rPr lang="en-US" sz="900" b="1" baseline="300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nor</a:t>
                      </a:r>
                      <a:endParaRPr lang="en-US" sz="9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 b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P53</a:t>
                      </a:r>
                      <a:r>
                        <a:rPr lang="en-US" sz="900" b="1" baseline="300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stDNA</a:t>
                      </a:r>
                      <a:r>
                        <a:rPr lang="en-US" sz="900" b="1" baseline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sz="900" b="1" baseline="30000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adjusted</a:t>
                      </a:r>
                      <a:r>
                        <a:rPr lang="en-US" sz="900" b="1" baseline="30000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abn</a:t>
                      </a:r>
                      <a:endParaRPr lang="en-US" sz="9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Total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Kappa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(95% CI)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78029954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P53</a:t>
                      </a:r>
                      <a:r>
                        <a:rPr lang="en-US" sz="900" b="1" baseline="30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IHCnor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 b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</a:t>
                      </a:r>
                      <a:endParaRPr lang="en-US" sz="9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3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.08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(-0.53, 0.69)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18616146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P53</a:t>
                      </a:r>
                      <a:r>
                        <a:rPr lang="en-US" sz="900" b="1" baseline="30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IHCabn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6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8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18492572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Total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3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8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1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11391668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P53</a:t>
                      </a:r>
                      <a:r>
                        <a:rPr lang="en-US" sz="900" b="1" baseline="30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ctDNAnor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P53</a:t>
                      </a:r>
                      <a:r>
                        <a:rPr lang="en-US" sz="900" b="1" baseline="30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ctDNAabn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Total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Kappa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(95% CI)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56756675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P53</a:t>
                      </a:r>
                      <a:r>
                        <a:rPr lang="en-US" sz="900" b="1" baseline="300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stDNA </a:t>
                      </a:r>
                      <a:r>
                        <a:rPr lang="en-US" sz="900" b="1" baseline="30000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adjusted</a:t>
                      </a:r>
                      <a:r>
                        <a:rPr lang="en-US" sz="900" b="1" baseline="30000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nor</a:t>
                      </a:r>
                      <a:endParaRPr lang="en-US" sz="9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3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.54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(-0.02, 1.00)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12344842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P53</a:t>
                      </a:r>
                      <a:r>
                        <a:rPr lang="en-US" sz="900" b="1" baseline="300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stDNA</a:t>
                      </a:r>
                      <a:r>
                        <a:rPr lang="en-US" sz="900" b="1" baseline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sz="900" b="1" baseline="30000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adjusted</a:t>
                      </a:r>
                      <a:r>
                        <a:rPr lang="en-US" sz="900" b="1" baseline="30000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abn</a:t>
                      </a:r>
                      <a:endParaRPr lang="en-US" sz="9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7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8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03694469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Total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3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8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1</a:t>
                      </a:r>
                      <a:endParaRPr lang="en-US" sz="9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347183563"/>
                  </a:ext>
                </a:extLst>
              </a:tr>
            </a:tbl>
          </a:graphicData>
        </a:graphic>
      </p:graphicFrame>
      <p:graphicFrame>
        <p:nvGraphicFramePr>
          <p:cNvPr id="6" name="Table 5"/>
          <p:cNvGraphicFramePr>
            <a:graphicFrameLocks noGrp="1"/>
          </p:cNvGraphicFramePr>
          <p:nvPr>
            <p:extLst/>
          </p:nvPr>
        </p:nvGraphicFramePr>
        <p:xfrm>
          <a:off x="5942947" y="480109"/>
          <a:ext cx="5823585" cy="3032897"/>
        </p:xfrm>
        <a:graphic>
          <a:graphicData uri="http://schemas.openxmlformats.org/drawingml/2006/table">
            <a:tbl>
              <a:tblPr/>
              <a:tblGrid>
                <a:gridCol w="1314450">
                  <a:extLst>
                    <a:ext uri="{9D8B030D-6E8A-4147-A177-3AD203B41FA5}">
                      <a16:colId xmlns:a16="http://schemas.microsoft.com/office/drawing/2014/main" val="4050594023"/>
                    </a:ext>
                  </a:extLst>
                </a:gridCol>
                <a:gridCol w="1435735">
                  <a:extLst>
                    <a:ext uri="{9D8B030D-6E8A-4147-A177-3AD203B41FA5}">
                      <a16:colId xmlns:a16="http://schemas.microsoft.com/office/drawing/2014/main" val="2976346431"/>
                    </a:ext>
                  </a:extLst>
                </a:gridCol>
                <a:gridCol w="958850">
                  <a:extLst>
                    <a:ext uri="{9D8B030D-6E8A-4147-A177-3AD203B41FA5}">
                      <a16:colId xmlns:a16="http://schemas.microsoft.com/office/drawing/2014/main" val="4127847364"/>
                    </a:ext>
                  </a:extLst>
                </a:gridCol>
                <a:gridCol w="611505">
                  <a:extLst>
                    <a:ext uri="{9D8B030D-6E8A-4147-A177-3AD203B41FA5}">
                      <a16:colId xmlns:a16="http://schemas.microsoft.com/office/drawing/2014/main" val="2508366342"/>
                    </a:ext>
                  </a:extLst>
                </a:gridCol>
                <a:gridCol w="131445">
                  <a:extLst>
                    <a:ext uri="{9D8B030D-6E8A-4147-A177-3AD203B41FA5}">
                      <a16:colId xmlns:a16="http://schemas.microsoft.com/office/drawing/2014/main" val="3054309304"/>
                    </a:ext>
                  </a:extLst>
                </a:gridCol>
                <a:gridCol w="432435">
                  <a:extLst>
                    <a:ext uri="{9D8B030D-6E8A-4147-A177-3AD203B41FA5}">
                      <a16:colId xmlns:a16="http://schemas.microsoft.com/office/drawing/2014/main" val="2352375345"/>
                    </a:ext>
                  </a:extLst>
                </a:gridCol>
                <a:gridCol w="939165">
                  <a:extLst>
                    <a:ext uri="{9D8B030D-6E8A-4147-A177-3AD203B41FA5}">
                      <a16:colId xmlns:a16="http://schemas.microsoft.com/office/drawing/2014/main" val="1164612430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RB1</a:t>
                      </a:r>
                      <a:r>
                        <a:rPr lang="en-US" sz="900" b="1" baseline="30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ctDNAnor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RB1</a:t>
                      </a:r>
                      <a:r>
                        <a:rPr lang="en-US" sz="900" b="1" baseline="30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ctDNAabn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Total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Kappa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(95% CI)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2332452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RB1</a:t>
                      </a:r>
                      <a:r>
                        <a:rPr lang="en-US" sz="900" b="1" baseline="30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IHCnor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1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3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4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.33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(-0.18, 0.83)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40648024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RB1</a:t>
                      </a:r>
                      <a:r>
                        <a:rPr lang="en-US" sz="900" b="1" baseline="30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IHCabn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57628808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Total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1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4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5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4561344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RB1</a:t>
                      </a:r>
                      <a:r>
                        <a:rPr lang="en-US" sz="900" b="1" baseline="30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stDNAnor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RB1</a:t>
                      </a:r>
                      <a:r>
                        <a:rPr lang="en-US" sz="900" b="1" baseline="30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stDNAabn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Total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Kappa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(95% CI)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36532803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RB1</a:t>
                      </a:r>
                      <a:r>
                        <a:rPr lang="en-US" sz="900" b="1" baseline="30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IHCnor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9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0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-0.10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(-0.24, 0.04)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97262550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RB1</a:t>
                      </a:r>
                      <a:r>
                        <a:rPr lang="en-US" sz="900" b="1" baseline="30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IHCabn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21665058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Total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0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1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11615377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RB1</a:t>
                      </a:r>
                      <a:r>
                        <a:rPr lang="en-US" sz="900" b="1" baseline="30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ctDNAnor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RB1</a:t>
                      </a:r>
                      <a:r>
                        <a:rPr lang="en-US" sz="900" b="1" baseline="30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ctDNAabn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Total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Kappa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(95% CI)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12970083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RB1</a:t>
                      </a:r>
                      <a:r>
                        <a:rPr lang="en-US" sz="900" b="1" baseline="300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stDNAnor</a:t>
                      </a:r>
                      <a:endParaRPr lang="en-US" sz="9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8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0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.42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(-0.17, 1.00)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81325947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RB1</a:t>
                      </a:r>
                      <a:r>
                        <a:rPr lang="en-US" sz="900" b="1" baseline="30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stDNAabn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15964482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Total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8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3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1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65939584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 b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RB1</a:t>
                      </a:r>
                      <a:r>
                        <a:rPr lang="en-US" sz="900" b="1" baseline="300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stDNA </a:t>
                      </a:r>
                      <a:r>
                        <a:rPr lang="en-US" sz="900" b="1" baseline="30000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adjusted</a:t>
                      </a:r>
                      <a:r>
                        <a:rPr lang="en-US" sz="900" b="1" baseline="30000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nor</a:t>
                      </a:r>
                      <a:endParaRPr lang="en-US" sz="9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 b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RB1</a:t>
                      </a:r>
                      <a:r>
                        <a:rPr lang="en-US" sz="900" b="1" baseline="300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stDNA </a:t>
                      </a:r>
                      <a:r>
                        <a:rPr lang="en-US" sz="900" b="1" baseline="30000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adjusted</a:t>
                      </a:r>
                      <a:r>
                        <a:rPr lang="en-US" sz="900" b="1" baseline="30000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abn</a:t>
                      </a:r>
                      <a:endParaRPr lang="en-US" sz="9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Total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Kappa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(95% CI)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63610799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RB1</a:t>
                      </a:r>
                      <a:r>
                        <a:rPr lang="en-US" sz="900" b="1" baseline="30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IHCnor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4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6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0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.11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(-0.11, 0.33)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15497848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RB1</a:t>
                      </a:r>
                      <a:r>
                        <a:rPr lang="en-US" sz="900" b="1" baseline="30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IHCabn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9568080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Total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4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7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1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11477131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RB1</a:t>
                      </a:r>
                      <a:r>
                        <a:rPr lang="en-US" sz="900" b="1" baseline="30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ctDNAnor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RB1</a:t>
                      </a:r>
                      <a:r>
                        <a:rPr lang="en-US" sz="900" b="1" baseline="30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ctDNAabn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Total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Kappa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(95% CI)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20835288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RB1</a:t>
                      </a:r>
                      <a:r>
                        <a:rPr lang="en-US" sz="900" b="1" baseline="300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stDNA </a:t>
                      </a:r>
                      <a:r>
                        <a:rPr lang="en-US" sz="900" b="1" baseline="30000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adjusted</a:t>
                      </a:r>
                      <a:r>
                        <a:rPr lang="en-US" sz="900" b="1" baseline="30000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nor</a:t>
                      </a:r>
                      <a:endParaRPr lang="en-US" sz="9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4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4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.35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(-0.03, 0.74)</a:t>
                      </a:r>
                      <a:endParaRPr lang="en-US" sz="9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27474516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RB1</a:t>
                      </a:r>
                      <a:r>
                        <a:rPr lang="en-US" sz="900" b="1" baseline="300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stDNA</a:t>
                      </a:r>
                      <a:r>
                        <a:rPr lang="en-US" sz="900" b="1" baseline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sz="900" b="1" baseline="30000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adjusted</a:t>
                      </a:r>
                      <a:r>
                        <a:rPr lang="en-US" sz="900" b="1" baseline="30000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abn</a:t>
                      </a:r>
                      <a:endParaRPr lang="en-US" sz="9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4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3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7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5472969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Total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8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3</a:t>
                      </a:r>
                      <a:endParaRPr lang="en-US" sz="9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1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805153955"/>
                  </a:ext>
                </a:extLst>
              </a:tr>
            </a:tbl>
          </a:graphicData>
        </a:graphic>
      </p:graphicFrame>
      <p:graphicFrame>
        <p:nvGraphicFramePr>
          <p:cNvPr id="8" name="Table 7"/>
          <p:cNvGraphicFramePr>
            <a:graphicFrameLocks noGrp="1"/>
          </p:cNvGraphicFramePr>
          <p:nvPr>
            <p:extLst/>
          </p:nvPr>
        </p:nvGraphicFramePr>
        <p:xfrm>
          <a:off x="3058460" y="3609640"/>
          <a:ext cx="5899785" cy="3143589"/>
        </p:xfrm>
        <a:graphic>
          <a:graphicData uri="http://schemas.openxmlformats.org/drawingml/2006/table">
            <a:tbl>
              <a:tblPr/>
              <a:tblGrid>
                <a:gridCol w="1314450">
                  <a:extLst>
                    <a:ext uri="{9D8B030D-6E8A-4147-A177-3AD203B41FA5}">
                      <a16:colId xmlns:a16="http://schemas.microsoft.com/office/drawing/2014/main" val="1344527948"/>
                    </a:ext>
                  </a:extLst>
                </a:gridCol>
                <a:gridCol w="1435735">
                  <a:extLst>
                    <a:ext uri="{9D8B030D-6E8A-4147-A177-3AD203B41FA5}">
                      <a16:colId xmlns:a16="http://schemas.microsoft.com/office/drawing/2014/main" val="1620574373"/>
                    </a:ext>
                  </a:extLst>
                </a:gridCol>
                <a:gridCol w="1035050">
                  <a:extLst>
                    <a:ext uri="{9D8B030D-6E8A-4147-A177-3AD203B41FA5}">
                      <a16:colId xmlns:a16="http://schemas.microsoft.com/office/drawing/2014/main" val="1615412394"/>
                    </a:ext>
                  </a:extLst>
                </a:gridCol>
                <a:gridCol w="611505">
                  <a:extLst>
                    <a:ext uri="{9D8B030D-6E8A-4147-A177-3AD203B41FA5}">
                      <a16:colId xmlns:a16="http://schemas.microsoft.com/office/drawing/2014/main" val="506552609"/>
                    </a:ext>
                  </a:extLst>
                </a:gridCol>
                <a:gridCol w="131445">
                  <a:extLst>
                    <a:ext uri="{9D8B030D-6E8A-4147-A177-3AD203B41FA5}">
                      <a16:colId xmlns:a16="http://schemas.microsoft.com/office/drawing/2014/main" val="721048741"/>
                    </a:ext>
                  </a:extLst>
                </a:gridCol>
                <a:gridCol w="432435">
                  <a:extLst>
                    <a:ext uri="{9D8B030D-6E8A-4147-A177-3AD203B41FA5}">
                      <a16:colId xmlns:a16="http://schemas.microsoft.com/office/drawing/2014/main" val="459828316"/>
                    </a:ext>
                  </a:extLst>
                </a:gridCol>
                <a:gridCol w="939165">
                  <a:extLst>
                    <a:ext uri="{9D8B030D-6E8A-4147-A177-3AD203B41FA5}">
                      <a16:colId xmlns:a16="http://schemas.microsoft.com/office/drawing/2014/main" val="1171585260"/>
                    </a:ext>
                  </a:extLst>
                </a:gridCol>
              </a:tblGrid>
              <a:tr h="183141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PTEN</a:t>
                      </a:r>
                      <a:r>
                        <a:rPr lang="en-US" sz="900" b="1" baseline="30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ctDNAnor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PTEN</a:t>
                      </a:r>
                      <a:r>
                        <a:rPr lang="en-US" sz="900" b="1" baseline="30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ctDNAabn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Total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Kappa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(95% CI)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888195971"/>
                  </a:ext>
                </a:extLst>
              </a:tr>
              <a:tr h="152598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PTEN</a:t>
                      </a:r>
                      <a:r>
                        <a:rPr lang="en-US" sz="900" b="1" baseline="30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IHCnor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7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8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.59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(0.19, 1.00)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528388001"/>
                  </a:ext>
                </a:extLst>
              </a:tr>
              <a:tr h="152598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PTEN</a:t>
                      </a:r>
                      <a:r>
                        <a:rPr lang="en-US" sz="900" b="1" baseline="30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IHCabn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5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7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01115119"/>
                  </a:ext>
                </a:extLst>
              </a:tr>
              <a:tr h="152598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Total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9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6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5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454322732"/>
                  </a:ext>
                </a:extLst>
              </a:tr>
              <a:tr h="183141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PTEN</a:t>
                      </a:r>
                      <a:r>
                        <a:rPr lang="en-US" sz="900" b="1" baseline="30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stDNAnor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PTEN</a:t>
                      </a:r>
                      <a:r>
                        <a:rPr lang="en-US" sz="900" b="1" baseline="30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stDNAabn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Total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Kappa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(95% CI)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21434318"/>
                  </a:ext>
                </a:extLst>
              </a:tr>
              <a:tr h="152598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PTEN</a:t>
                      </a:r>
                      <a:r>
                        <a:rPr lang="en-US" sz="900" b="1" baseline="30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IHCnor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5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5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.15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(-0.14, 0.45)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58175135"/>
                  </a:ext>
                </a:extLst>
              </a:tr>
              <a:tr h="152598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PTEN</a:t>
                      </a:r>
                      <a:r>
                        <a:rPr lang="en-US" sz="900" b="1" baseline="30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IHCabn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5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6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844059220"/>
                  </a:ext>
                </a:extLst>
              </a:tr>
              <a:tr h="152598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Total</a:t>
                      </a:r>
                      <a:endParaRPr lang="en-US" sz="9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0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1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319318627"/>
                  </a:ext>
                </a:extLst>
              </a:tr>
              <a:tr h="152598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PTEN</a:t>
                      </a:r>
                      <a:r>
                        <a:rPr lang="en-US" sz="900" b="1" baseline="30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ctDNAnor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PTEN</a:t>
                      </a:r>
                      <a:r>
                        <a:rPr lang="en-US" sz="900" b="1" baseline="30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ctDNAabn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Total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Kappa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(95% CI)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797704604"/>
                  </a:ext>
                </a:extLst>
              </a:tr>
              <a:tr h="152598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PTEN</a:t>
                      </a:r>
                      <a:r>
                        <a:rPr lang="en-US" sz="900" b="1" baseline="30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stDNAnor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7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3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0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.30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(-0.18, 0.78)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374765747"/>
                  </a:ext>
                </a:extLst>
              </a:tr>
              <a:tr h="152598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PTEN</a:t>
                      </a:r>
                      <a:r>
                        <a:rPr lang="en-US" sz="900" b="1" baseline="30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stDNAabn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604112891"/>
                  </a:ext>
                </a:extLst>
              </a:tr>
              <a:tr h="152598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Total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7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4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1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295505673"/>
                  </a:ext>
                </a:extLst>
              </a:tr>
              <a:tr h="183141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 b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PTEN</a:t>
                      </a:r>
                      <a:r>
                        <a:rPr lang="en-US" sz="900" b="1" baseline="300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stDNA </a:t>
                      </a:r>
                      <a:r>
                        <a:rPr lang="en-US" sz="900" b="1" baseline="30000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adjusted</a:t>
                      </a:r>
                      <a:r>
                        <a:rPr lang="en-US" sz="900" b="1" baseline="30000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nor</a:t>
                      </a:r>
                      <a:endParaRPr lang="en-US" sz="9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 b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PTEN</a:t>
                      </a:r>
                      <a:r>
                        <a:rPr lang="en-US" sz="900" b="1" baseline="300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stDNA </a:t>
                      </a:r>
                      <a:r>
                        <a:rPr lang="en-US" sz="900" b="1" baseline="30000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adjusted</a:t>
                      </a:r>
                      <a:r>
                        <a:rPr lang="en-US" sz="900" b="1" baseline="30000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abn</a:t>
                      </a:r>
                      <a:endParaRPr lang="en-US" sz="9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Total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Kappa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(95% CI)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828602586"/>
                  </a:ext>
                </a:extLst>
              </a:tr>
              <a:tr h="152598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PTEN</a:t>
                      </a:r>
                      <a:r>
                        <a:rPr lang="en-US" sz="900" b="1" baseline="30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IHCnor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5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5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.65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(0.23, 1.00)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332071306"/>
                  </a:ext>
                </a:extLst>
              </a:tr>
              <a:tr h="152598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PTEN</a:t>
                      </a:r>
                      <a:r>
                        <a:rPr lang="en-US" sz="900" b="1" baseline="30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IHCabn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4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6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50836963"/>
                  </a:ext>
                </a:extLst>
              </a:tr>
              <a:tr h="152598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Total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7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4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1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107452945"/>
                  </a:ext>
                </a:extLst>
              </a:tr>
              <a:tr h="152598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PTEN</a:t>
                      </a:r>
                      <a:r>
                        <a:rPr lang="en-US" sz="900" b="1" baseline="30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ctDNAnor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PTEN</a:t>
                      </a:r>
                      <a:r>
                        <a:rPr lang="en-US" sz="900" b="1" baseline="30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ctDNAabn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Total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Kappa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(95% CI)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489031534"/>
                  </a:ext>
                </a:extLst>
              </a:tr>
              <a:tr h="152598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PTEN</a:t>
                      </a:r>
                      <a:r>
                        <a:rPr lang="en-US" sz="900" b="1" baseline="300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stDNA</a:t>
                      </a:r>
                      <a:r>
                        <a:rPr lang="en-US" sz="900" b="1" baseline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sz="900" b="1" baseline="30000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adjusted</a:t>
                      </a:r>
                      <a:r>
                        <a:rPr lang="en-US" sz="900" b="1" baseline="30000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nor</a:t>
                      </a:r>
                      <a:endParaRPr lang="en-US" sz="9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6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7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.61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(0.12, 1.00)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281695698"/>
                  </a:ext>
                </a:extLst>
              </a:tr>
              <a:tr h="152598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PTEN</a:t>
                      </a:r>
                      <a:r>
                        <a:rPr lang="en-US" sz="900" b="1" baseline="300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stDNA</a:t>
                      </a:r>
                      <a:r>
                        <a:rPr lang="en-US" sz="900" b="1" baseline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sz="900" b="1" baseline="30000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adjusted</a:t>
                      </a:r>
                      <a:r>
                        <a:rPr lang="en-US" sz="900" b="1" baseline="30000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abn</a:t>
                      </a:r>
                      <a:endParaRPr lang="en-US" sz="9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3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4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412590489"/>
                  </a:ext>
                </a:extLst>
              </a:tr>
              <a:tr h="152598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Total</a:t>
                      </a:r>
                      <a:endParaRPr lang="en-US" sz="9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7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4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1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66884776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96112783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655</Words>
  <Application>Microsoft Office PowerPoint</Application>
  <PresentationFormat>Widescreen</PresentationFormat>
  <Paragraphs>424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>UVA Health System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Viscuse, Paul *HS</dc:creator>
  <cp:lastModifiedBy>Viscuse, Paul *HS</cp:lastModifiedBy>
  <cp:revision>1</cp:revision>
  <dcterms:created xsi:type="dcterms:W3CDTF">2023-09-07T19:40:18Z</dcterms:created>
  <dcterms:modified xsi:type="dcterms:W3CDTF">2023-09-07T19:40:26Z</dcterms:modified>
</cp:coreProperties>
</file>